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327"/>
  </p:normalViewPr>
  <p:slideViewPr>
    <p:cSldViewPr snapToGrid="0" snapToObjects="1">
      <p:cViewPr varScale="1">
        <p:scale>
          <a:sx n="121" d="100"/>
          <a:sy n="121" d="100"/>
        </p:scale>
        <p:origin x="200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B54DAD-13C7-DB42-B814-67BE826020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7DFAA4D-F7BA-7940-B9B0-07C4C02B50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75DB47-7762-714D-A29B-F72458654A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DE9220-FED5-C745-9555-78155CAA8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FFE4D3-E8D4-CF49-AB9D-B2E26A06D7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507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EC6C5C-3E8A-C14E-AEAE-AB509AA9D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E1B8DB4-954E-0647-B156-8FA17895B2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06CAAAF-8EC7-C643-AA5D-9EB032C10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BA34E0-6D5A-3440-84A8-37F022B44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6BB29E-CE9F-2642-B0DA-0D868691B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866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B692270-E235-FC48-9F86-F2A386B918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A686F2F-24CE-4C43-95E2-C85CEB97CC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A73135-50AC-E347-BDE1-3D1B266B1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FB4891-4DAB-AB43-9E43-1351AC977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1A1D3E-E4CF-3046-A8BE-577399DCA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782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2AFDBB-134B-2E42-8E50-F07B94AFB0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B467213-811E-6D4A-9C9B-A74FA20F15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5B590EA-E78D-9848-8FE9-08CF8CD84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DE4C25A-25B3-2743-9A0A-D85EFB344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2AB0BA-FE21-5641-8DF1-1177ACE8A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91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8D4484-59E2-F941-9E0B-5749AF353E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EAA60A-B4AD-F640-999A-DF5A6E9FF9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FDD4BB-5CDD-8449-9987-5B896B1B7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F05D02-0093-1945-8843-2411019F7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05895E-AB60-D349-A998-721283981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16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0777CE-DB50-4E4A-9634-FCB1A75140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6B872C0-ACCB-4648-AE07-E194EC921F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10FD6B9-AB00-A148-A766-028182A448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DBF5DF1-EAEF-BB49-AB1E-4E5817A5B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748C8D3-D57B-7A47-9D19-255C9080D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0A1CABD-F963-9348-9582-5E56A8434F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6239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E66530-13C5-FB48-8053-B800224225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0873BD9-CA43-574D-9220-4C9E111FA1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487B617-F617-5742-81BD-1B380486AB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24AEF7D-3679-4B41-BA78-5893BB1331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F22228F-743F-0145-915D-43BF332E13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27FB546-CA4B-B147-B80F-ADE8057DF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2FCD63A-FAFC-C24B-A0E3-11281287A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C961388-5179-1A4F-97A2-1D8EFFF20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262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C833A0-2DDD-064F-950E-979DEF06AC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BE77DE7-5847-724C-9681-229770AAB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BF2DB69-C06B-6C4B-993E-5C13F830A0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9E0E8EF-2710-8744-9CE6-3F82A1A8C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4753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2235B69-2406-3747-AE00-7AD0E2B20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927B9D1-DEE3-7C44-BCC1-07E7A62D5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2D44EE4-6B60-F248-A068-87B207380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5770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2BA6E1-242E-C64C-A7B8-E966075359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E66160E-ED66-944B-9DB5-4976C80656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50F05DE-0FF3-A84A-B2C2-409EAB8BAB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9425D21-D348-584E-BE56-C47E9FF95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36F3887-9334-AB44-BDD8-D12570729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5F655D-C7E0-5147-B200-0870AD9E1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1730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9746AE-8B80-B049-BAAB-92C0FABA24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9F2029A-CE2F-0D49-90F3-B3550CACCC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214784D-0337-7E4A-9818-AB11224D64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43E4A86-756C-6F41-832E-B25AB26CD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7AB833-860F-964B-BBC0-48BB101B2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02E92EC-C52E-3C4D-8523-61E798413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6900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6AE48C7-2364-B247-A8F1-8F0AB53C4F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293F41E-C7E3-EE40-A848-F6C6484584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AF14DA-CDF7-7F4C-91D6-FE01DC01D7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A1758-01B6-5145-AE71-3B39FE61287F}" type="datetimeFigureOut">
              <a:rPr kumimoji="1" lang="ja-JP" altLang="en-US" smtClean="0"/>
              <a:t>2022/4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D2AF8F-3421-1C41-BCF0-42EF2DEACF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FC94E9-59BE-4E43-83DC-9EC9C6E7F3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ECEDD-F161-CA41-A6E8-E79F0DD72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2725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03F1FC24-686B-F84C-8200-8B629ABBB55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2202" b="11481"/>
          <a:stretch/>
        </p:blipFill>
        <p:spPr>
          <a:xfrm>
            <a:off x="3717144" y="1493140"/>
            <a:ext cx="5039746" cy="4160039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72151A9-90AB-1C42-8353-E790684E3BE1}"/>
              </a:ext>
            </a:extLst>
          </p:cNvPr>
          <p:cNvSpPr txBox="1"/>
          <p:nvPr/>
        </p:nvSpPr>
        <p:spPr>
          <a:xfrm>
            <a:off x="6549844" y="2584191"/>
            <a:ext cx="1817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=0.017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8EEEA8B-BE66-0644-A2F5-56A5C5D9F2B8}"/>
              </a:ext>
            </a:extLst>
          </p:cNvPr>
          <p:cNvSpPr txBox="1"/>
          <p:nvPr/>
        </p:nvSpPr>
        <p:spPr>
          <a:xfrm>
            <a:off x="4225285" y="4223573"/>
            <a:ext cx="2324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DGFRA</a:t>
            </a:r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mp</a:t>
            </a:r>
            <a:endParaRPr kumimoji="1" lang="ja-JP" altLang="en-US" sz="140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AE791A5-34E2-BC47-B79F-33BDCB504BD7}"/>
              </a:ext>
            </a:extLst>
          </p:cNvPr>
          <p:cNvSpPr txBox="1"/>
          <p:nvPr/>
        </p:nvSpPr>
        <p:spPr>
          <a:xfrm>
            <a:off x="5942081" y="3736797"/>
            <a:ext cx="2324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DGFRA</a:t>
            </a:r>
            <a:r>
              <a:rPr kumimoji="1" lang="en-US" altLang="ja-JP" sz="14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act</a:t>
            </a:r>
            <a:endParaRPr kumimoji="1" lang="ja-JP" altLang="en-US" sz="140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AADA3600-5A42-444A-A761-FB47982732D6}"/>
              </a:ext>
            </a:extLst>
          </p:cNvPr>
          <p:cNvSpPr/>
          <p:nvPr/>
        </p:nvSpPr>
        <p:spPr>
          <a:xfrm>
            <a:off x="1523999" y="5872732"/>
            <a:ext cx="990074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</a:t>
            </a:r>
            <a:r>
              <a:rPr lang="en-US" altLang="ja-JP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Kaplan–Meier overall survival (OS) analysis of patients</a:t>
            </a:r>
            <a:r>
              <a:rPr lang="ja-JP" altLang="ja-JP" sz="1600" i="1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ja-JP" altLang="ja-JP" sz="1600" i="1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DH</a:t>
            </a:r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ild-type glioblastoma (GBM) belonging to the Memorial Sloan Kettering Cancer Center (MSKCC) cohort. </a:t>
            </a:r>
            <a:r>
              <a:rPr lang="ja-JP" altLang="ja-JP" sz="1600" i="1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DH</a:t>
            </a:r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ild-type GBM cases with </a:t>
            </a:r>
            <a:r>
              <a:rPr lang="ja-JP" altLang="ja-JP" sz="1600" i="1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GFRA</a:t>
            </a:r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mplification showed a significantly shorter OS than those without </a:t>
            </a:r>
            <a:r>
              <a:rPr lang="ja-JP" altLang="ja-JP" sz="1600" i="1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DGFRA</a:t>
            </a:r>
            <a:r>
              <a:rPr lang="ja-JP" altLang="ja-JP" sz="1600" kern="1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mplification in the MSKCC cohort.</a:t>
            </a:r>
            <a:endParaRPr lang="ja-JP" altLang="ja-JP" sz="1600" kern="10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4876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7</Words>
  <Application>Microsoft Macintosh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比嘉　那優大</dc:creator>
  <cp:lastModifiedBy>比嘉　那優大</cp:lastModifiedBy>
  <cp:revision>9</cp:revision>
  <dcterms:created xsi:type="dcterms:W3CDTF">2021-09-20T09:16:50Z</dcterms:created>
  <dcterms:modified xsi:type="dcterms:W3CDTF">2022-04-21T12:20:08Z</dcterms:modified>
</cp:coreProperties>
</file>